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8" r:id="rId3"/>
    <p:sldId id="257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85" autoAdjust="0"/>
    <p:restoredTop sz="94660"/>
  </p:normalViewPr>
  <p:slideViewPr>
    <p:cSldViewPr snapToGrid="0">
      <p:cViewPr>
        <p:scale>
          <a:sx n="120" d="100"/>
          <a:sy n="120" d="100"/>
        </p:scale>
        <p:origin x="792" y="8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9C1D98-3B9C-490A-B87E-6770F003D485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46A6C-20E5-42B0-B587-363A36766D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8281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4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B46A6C-20E5-42B0-B587-363A36766DB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85907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s3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B46A6C-20E5-42B0-B587-363A36766DB5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31661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ure</a:t>
            </a:r>
            <a:r>
              <a:rPr lang="en-US" altLang="zh-CN" baseline="0" dirty="0" smtClean="0"/>
              <a:t> s5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B46A6C-20E5-42B0-B587-363A36766DB5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6009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49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2560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76032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4079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2644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7669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1570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3416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673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478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4382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147C4-95F4-41F9-A8F9-1882A9922C8C}" type="datetimeFigureOut">
              <a:rPr lang="zh-CN" altLang="en-US" smtClean="0"/>
              <a:t>2022/10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AEF21E-65F9-4298-B70D-7CBC699F0E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8366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082" y="449801"/>
            <a:ext cx="3321973" cy="265185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6563" y="705447"/>
            <a:ext cx="2803121" cy="2335934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3182" y="9045632"/>
            <a:ext cx="4800600" cy="35814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97269" y="9045632"/>
            <a:ext cx="5153025" cy="334327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6"/>
          <a:srcRect r="4530"/>
          <a:stretch/>
        </p:blipFill>
        <p:spPr>
          <a:xfrm>
            <a:off x="9037797" y="1077478"/>
            <a:ext cx="3012798" cy="1946766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96334" y="1020895"/>
            <a:ext cx="3154081" cy="19914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7077" y="3555930"/>
            <a:ext cx="5381625" cy="307657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57402" y="3433565"/>
            <a:ext cx="5562600" cy="3362325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706547" y="3257638"/>
            <a:ext cx="5191125" cy="337185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11"/>
          <a:srcRect r="44533"/>
          <a:stretch/>
        </p:blipFill>
        <p:spPr>
          <a:xfrm>
            <a:off x="8421656" y="3555908"/>
            <a:ext cx="3053715" cy="3019425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83231" y="9117070"/>
            <a:ext cx="5391150" cy="3390900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157077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2A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5712116" y="227948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2F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161843" y="3371264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3B</a:t>
            </a:r>
            <a:endParaRPr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5436903" y="3371242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3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51716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83701" y="363775"/>
            <a:ext cx="2101027" cy="214323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4305" y="597302"/>
            <a:ext cx="3352168" cy="184799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67611" y="961597"/>
            <a:ext cx="2941269" cy="148369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72229" y="597302"/>
            <a:ext cx="3619771" cy="2002561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57077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4D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3255102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4L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5810306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4Q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8572229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4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630135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27695" y="3789807"/>
            <a:ext cx="2340165" cy="2111732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66735" y="748125"/>
            <a:ext cx="2066045" cy="2076198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97683" y="3752573"/>
            <a:ext cx="2330012" cy="2253868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02951" y="677101"/>
            <a:ext cx="2076198" cy="2192952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9654" y="3800353"/>
            <a:ext cx="2198029" cy="222341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7664" y="672024"/>
            <a:ext cx="2111732" cy="2198029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296354" y="1228508"/>
            <a:ext cx="2751343" cy="158887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57077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3F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2802053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3G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5447029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3H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8296354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3I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157077" y="3407131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3J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2946662" y="3403483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3K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5402077" y="3405594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3L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014426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750" y="3069202"/>
            <a:ext cx="4252110" cy="2132517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09241" y="365760"/>
            <a:ext cx="2955141" cy="1837746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96892" y="435960"/>
            <a:ext cx="2926781" cy="1900139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0471" y="567562"/>
            <a:ext cx="2813340" cy="1837746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57077" y="227970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5D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157077" y="2520007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5G</a:t>
            </a:r>
            <a:endParaRPr lang="zh-CN" altLang="en-US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12059" y="3237835"/>
            <a:ext cx="3531024" cy="1963884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07313" y="3028064"/>
            <a:ext cx="3706385" cy="2214791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4603182" y="2520007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6A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8131027" y="2523761"/>
            <a:ext cx="1183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S6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72378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45</Words>
  <Application>Microsoft Office PowerPoint</Application>
  <PresentationFormat>宽屏</PresentationFormat>
  <Paragraphs>25</Paragraphs>
  <Slides>4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9</cp:revision>
  <dcterms:created xsi:type="dcterms:W3CDTF">2022-10-22T11:34:18Z</dcterms:created>
  <dcterms:modified xsi:type="dcterms:W3CDTF">2022-10-22T13:36:22Z</dcterms:modified>
</cp:coreProperties>
</file>